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1979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443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989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337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476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378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015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285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217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549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8694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5BE42-8B53-4417-820A-D8B8302C9F9B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2C407-7B76-44F4-A1FF-280B711A01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256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6495" y="1072431"/>
            <a:ext cx="7854275" cy="571219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260045" y="82020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283940" y="632030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793801" y="628935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906562" y="811123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826312" y="655890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351417" y="655890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7012662" y="620423"/>
            <a:ext cx="1329466" cy="603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351417" y="265807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53684" y="3289905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OXL2</a:t>
            </a:r>
          </a:p>
        </p:txBody>
      </p:sp>
    </p:spTree>
    <p:extLst>
      <p:ext uri="{BB962C8B-B14F-4D97-AF65-F5344CB8AC3E}">
        <p14:creationId xmlns:p14="http://schemas.microsoft.com/office/powerpoint/2010/main" val="1396108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7083" y="1221035"/>
            <a:ext cx="7638035" cy="555493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009945" y="85766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033840" y="669491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543701" y="66639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656462" y="848584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576212" y="693351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101317" y="693351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8762562" y="657884"/>
            <a:ext cx="1329466" cy="603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101317" y="303268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595110" y="3998502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114198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Macintosh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4B</dc:title>
  <dc:creator>Christopher Brereton</dc:creator>
  <cp:lastModifiedBy>Mark Jones</cp:lastModifiedBy>
  <cp:revision>4</cp:revision>
  <dcterms:created xsi:type="dcterms:W3CDTF">2021-05-05T13:02:26Z</dcterms:created>
  <dcterms:modified xsi:type="dcterms:W3CDTF">2021-11-12T15:03:44Z</dcterms:modified>
</cp:coreProperties>
</file>